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2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7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7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9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6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318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596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88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206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34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77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57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819B936-A39E-4F0C-8E72-83823D8855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6898053"/>
              </p:ext>
            </p:extLst>
          </p:nvPr>
        </p:nvGraphicFramePr>
        <p:xfrm>
          <a:off x="463061" y="847579"/>
          <a:ext cx="5931878" cy="74488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65939">
                  <a:extLst>
                    <a:ext uri="{9D8B030D-6E8A-4147-A177-3AD203B41FA5}">
                      <a16:colId xmlns:a16="http://schemas.microsoft.com/office/drawing/2014/main" val="1892548952"/>
                    </a:ext>
                  </a:extLst>
                </a:gridCol>
                <a:gridCol w="2965939">
                  <a:extLst>
                    <a:ext uri="{9D8B030D-6E8A-4147-A177-3AD203B41FA5}">
                      <a16:colId xmlns:a16="http://schemas.microsoft.com/office/drawing/2014/main" val="1951518647"/>
                    </a:ext>
                  </a:extLst>
                </a:gridCol>
              </a:tblGrid>
              <a:tr h="395754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 Sites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Primers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2973727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1 (-4379/-4375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GACCACAGGACAAGCATTGA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TCTGCAGTGGAGAAATTTG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4754575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2 (-2402/-2395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ACG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GCCAATTTGCATACCAAAC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TCCCAAAGTGCTGGGATTA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105560"/>
                  </a:ext>
                </a:extLst>
              </a:tr>
              <a:tr h="5367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3 (-2228/-2225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AGATCGACACCACGGTGAA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GATCTCAGCTCACTGCAA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3532290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4 (-1926/-1923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A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CTTCACAGGAGGGACTGTG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GGAGGGCCACATAAACATGA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348187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5 (-1206/-1203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TCTGGTTGGGGAAGACAGA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ATGTTGCCCAAACTGGTCT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2121292"/>
                  </a:ext>
                </a:extLst>
              </a:tr>
              <a:tr h="71560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6 (-861/-858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A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AGCCTGGGTGACAGAGTGA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GCACTGGCTGTCTGGTCTT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1909645"/>
                  </a:ext>
                </a:extLst>
              </a:tr>
              <a:tr h="536707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7 (-133/-128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CA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CATTTAAAGCCACGGGAC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CGATTCTCTGCCTGGTTCC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6797659"/>
                  </a:ext>
                </a:extLst>
              </a:tr>
              <a:tr h="39575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8 (+243/+246)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AGAGCGGAGGGGAGAC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GTTCCTCACCCGCTTC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325606"/>
                  </a:ext>
                </a:extLst>
              </a:tr>
              <a:tr h="161012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9 (+608/+761) 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CGGTGGGAACAGGCCCTGGCCCGGCGCCCGCGGGCGGT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GGTTTGTTTACGTCCGAGGGCGG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TCCCTGGCGGGCGGCCTGGGTATCCTGCCCGGTG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G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TGTGTACCTCGGGG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TG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TGTGCTTGTGTGT</a:t>
                      </a:r>
                      <a:r>
                        <a:rPr lang="en-US" sz="1100" u="sng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T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: CTGTGCTCCTACGTGACTCG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Rev: 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GAGGTACACACTGCTG</a:t>
                      </a:r>
                      <a:r>
                        <a:rPr lang="ko-KR" sz="11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ko-K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041147"/>
                  </a:ext>
                </a:extLst>
              </a:tr>
              <a:tr h="395754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HRE10 (+901/+905)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GCGT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34" charset="-128"/>
                          <a:cs typeface="Times New Roman" panose="02020603050405020304" pitchFamily="18" charset="0"/>
                        </a:rPr>
                        <a:t>FW: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GCCTGTACACCAGCAGTG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: AGCCCCGGGTAGTAGGACT</a:t>
                      </a:r>
                      <a:endParaRPr lang="ko-K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60707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D68286C-60F2-4F34-9813-C2AE4376B84A}"/>
              </a:ext>
            </a:extLst>
          </p:cNvPr>
          <p:cNvSpPr txBox="1"/>
          <p:nvPr/>
        </p:nvSpPr>
        <p:spPr>
          <a:xfrm>
            <a:off x="1" y="211014"/>
            <a:ext cx="6775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5. Primers for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286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</TotalTime>
  <Words>140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jung Moon</dc:creator>
  <cp:lastModifiedBy>Moon Ejung</cp:lastModifiedBy>
  <cp:revision>24</cp:revision>
  <cp:lastPrinted>2018-12-27T23:59:30Z</cp:lastPrinted>
  <dcterms:created xsi:type="dcterms:W3CDTF">2018-12-27T23:58:40Z</dcterms:created>
  <dcterms:modified xsi:type="dcterms:W3CDTF">2021-05-20T15:24:55Z</dcterms:modified>
</cp:coreProperties>
</file>